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>
      <p:cViewPr>
        <p:scale>
          <a:sx n="200" d="100"/>
          <a:sy n="200" d="100"/>
        </p:scale>
        <p:origin x="106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6BFF7-6D16-6746-B729-82625EC290C5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17BB9-5493-5D4C-ABB8-8E8544FA2E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48416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6BFF7-6D16-6746-B729-82625EC290C5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17BB9-5493-5D4C-ABB8-8E8544FA2E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94939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6BFF7-6D16-6746-B729-82625EC290C5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17BB9-5493-5D4C-ABB8-8E8544FA2E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54799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6BFF7-6D16-6746-B729-82625EC290C5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17BB9-5493-5D4C-ABB8-8E8544FA2E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08435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6BFF7-6D16-6746-B729-82625EC290C5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17BB9-5493-5D4C-ABB8-8E8544FA2E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00779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6BFF7-6D16-6746-B729-82625EC290C5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17BB9-5493-5D4C-ABB8-8E8544FA2E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36842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6BFF7-6D16-6746-B729-82625EC290C5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17BB9-5493-5D4C-ABB8-8E8544FA2E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6BFF7-6D16-6746-B729-82625EC290C5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17BB9-5493-5D4C-ABB8-8E8544FA2E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74712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6BFF7-6D16-6746-B729-82625EC290C5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17BB9-5493-5D4C-ABB8-8E8544FA2E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5411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6BFF7-6D16-6746-B729-82625EC290C5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17BB9-5493-5D4C-ABB8-8E8544FA2E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35317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6BFF7-6D16-6746-B729-82625EC290C5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17BB9-5493-5D4C-ABB8-8E8544FA2E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66274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926BFF7-6D16-6746-B729-82625EC290C5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3217BB9-5493-5D4C-ABB8-8E8544FA2E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16743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een and orange squares&#10;&#10;AI-generated content may be incorrect.">
            <a:extLst>
              <a:ext uri="{FF2B5EF4-FFF2-40B4-BE49-F238E27FC236}">
                <a16:creationId xmlns:a16="http://schemas.microsoft.com/office/drawing/2014/main" id="{913C1AAF-AF81-7FAF-AEA0-21FCFDA159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8654" y="541280"/>
            <a:ext cx="5978769" cy="2524217"/>
          </a:xfrm>
          <a:prstGeom prst="rect">
            <a:avLst/>
          </a:prstGeom>
        </p:spPr>
      </p:pic>
      <p:sp>
        <p:nvSpPr>
          <p:cNvPr id="6" name="Titre 1">
            <a:extLst>
              <a:ext uri="{FF2B5EF4-FFF2-40B4-BE49-F238E27FC236}">
                <a16:creationId xmlns:a16="http://schemas.microsoft.com/office/drawing/2014/main" id="{65B3E882-DC99-6B45-E150-91A703586205}"/>
              </a:ext>
            </a:extLst>
          </p:cNvPr>
          <p:cNvSpPr txBox="1">
            <a:spLocks/>
          </p:cNvSpPr>
          <p:nvPr/>
        </p:nvSpPr>
        <p:spPr>
          <a:xfrm>
            <a:off x="418654" y="3638550"/>
            <a:ext cx="5978769" cy="861835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lnSpc>
                <a:spcPct val="150000"/>
              </a:lnSpc>
            </a:pP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1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. Box plots of the Necrosis (panel </a:t>
            </a: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A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) and Pycnidia (panel </a:t>
            </a: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B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) AUDPC scores showing significant differences between the </a:t>
            </a:r>
            <a:r>
              <a:rPr lang="en-GB" sz="1200" i="1" dirty="0" err="1">
                <a:latin typeface="Times New Roman" panose="02020603050405020304" pitchFamily="18" charset="0"/>
                <a:ea typeface="Calibri" panose="020F0502020204030204" pitchFamily="34" charset="0"/>
              </a:rPr>
              <a:t>Zymoseptoria</a:t>
            </a:r>
            <a:r>
              <a:rPr lang="en-GB" sz="1200" i="1" dirty="0">
                <a:latin typeface="Times New Roman" panose="02020603050405020304" pitchFamily="18" charset="0"/>
                <a:ea typeface="Calibri" panose="020F0502020204030204" pitchFamily="34" charset="0"/>
              </a:rPr>
              <a:t> tritici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isolates T2 and T46 when tested on the soft red winter wheat panel population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96378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42</Words>
  <Application>Microsoft Macintosh PowerPoint</Application>
  <PresentationFormat>Letter Paper (8.5x11 in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tephen Goodwin</dc:creator>
  <cp:lastModifiedBy>Stephen Goodwin</cp:lastModifiedBy>
  <cp:revision>2</cp:revision>
  <dcterms:created xsi:type="dcterms:W3CDTF">2025-12-10T19:33:53Z</dcterms:created>
  <dcterms:modified xsi:type="dcterms:W3CDTF">2025-12-10T19:43:25Z</dcterms:modified>
</cp:coreProperties>
</file>